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35" r:id="rId2"/>
  </p:sldIdLst>
  <p:sldSz cx="9144000" cy="6858000" type="screen4x3"/>
  <p:notesSz cx="7010400" cy="92964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9999"/>
    <a:srgbClr val="5CA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050" autoAdjust="0"/>
    <p:restoredTop sz="87515" autoAdjust="0"/>
  </p:normalViewPr>
  <p:slideViewPr>
    <p:cSldViewPr snapToGrid="0" snapToObjects="1">
      <p:cViewPr>
        <p:scale>
          <a:sx n="90" d="100"/>
          <a:sy n="90" d="100"/>
        </p:scale>
        <p:origin x="-1650" y="-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F$6:$F$14</c:f>
                <c:numCache>
                  <c:formatCode>General</c:formatCode>
                  <c:ptCount val="9"/>
                  <c:pt idx="0">
                    <c:v>8.1812610472337413E-2</c:v>
                  </c:pt>
                  <c:pt idx="1">
                    <c:v>0.24136258522206677</c:v>
                  </c:pt>
                  <c:pt idx="2">
                    <c:v>0.85640350387499997</c:v>
                  </c:pt>
                  <c:pt idx="3">
                    <c:v>0.18051629997838012</c:v>
                  </c:pt>
                  <c:pt idx="4">
                    <c:v>1.86748140350387</c:v>
                  </c:pt>
                  <c:pt idx="5">
                    <c:v>4.9495134505785417E-2</c:v>
                  </c:pt>
                  <c:pt idx="6">
                    <c:v>0.13096552007664322</c:v>
                  </c:pt>
                  <c:pt idx="7">
                    <c:v>0.16001383804444988</c:v>
                  </c:pt>
                  <c:pt idx="8">
                    <c:v>6.550766665812307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6:$B$14</c:f>
              <c:strCache>
                <c:ptCount val="9"/>
                <c:pt idx="0">
                  <c:v>NEG</c:v>
                </c:pt>
                <c:pt idx="1">
                  <c:v>CCNB1</c:v>
                </c:pt>
                <c:pt idx="2">
                  <c:v>CCNB2</c:v>
                </c:pt>
                <c:pt idx="3">
                  <c:v>CDK1</c:v>
                </c:pt>
                <c:pt idx="4">
                  <c:v>TOP2A</c:v>
                </c:pt>
                <c:pt idx="5">
                  <c:v>USP15</c:v>
                </c:pt>
                <c:pt idx="6">
                  <c:v>MTCH1</c:v>
                </c:pt>
                <c:pt idx="7">
                  <c:v>SASH1</c:v>
                </c:pt>
                <c:pt idx="8">
                  <c:v>CDCA7L</c:v>
                </c:pt>
              </c:strCache>
            </c:strRef>
          </c:cat>
          <c:val>
            <c:numRef>
              <c:f>Sheet1!$E$6:$E$14</c:f>
              <c:numCache>
                <c:formatCode>General</c:formatCode>
                <c:ptCount val="9"/>
                <c:pt idx="0" formatCode="0.00">
                  <c:v>0.25</c:v>
                </c:pt>
                <c:pt idx="1">
                  <c:v>2.8416091753022115</c:v>
                </c:pt>
                <c:pt idx="2">
                  <c:v>4.0122636622499996</c:v>
                </c:pt>
                <c:pt idx="3" formatCode="0.00">
                  <c:v>3.4752166808592251</c:v>
                </c:pt>
                <c:pt idx="4" formatCode="0.00">
                  <c:v>12.7546312263662</c:v>
                </c:pt>
                <c:pt idx="5" formatCode="0.00">
                  <c:v>0.34079536404898053</c:v>
                </c:pt>
                <c:pt idx="6" formatCode="0.00">
                  <c:v>0.5161663417857455</c:v>
                </c:pt>
                <c:pt idx="7" formatCode="0.00">
                  <c:v>0.25916139319696502</c:v>
                </c:pt>
                <c:pt idx="8" formatCode="0.00">
                  <c:v>0.519250237128065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9920640"/>
        <c:axId val="225370880"/>
      </c:barChart>
      <c:catAx>
        <c:axId val="219920640"/>
        <c:scaling>
          <c:orientation val="minMax"/>
        </c:scaling>
        <c:delete val="0"/>
        <c:axPos val="b"/>
        <c:majorTickMark val="out"/>
        <c:minorTickMark val="none"/>
        <c:tickLblPos val="nextTo"/>
        <c:crossAx val="225370880"/>
        <c:crosses val="autoZero"/>
        <c:auto val="1"/>
        <c:lblAlgn val="ctr"/>
        <c:lblOffset val="100"/>
        <c:noMultiLvlLbl val="0"/>
      </c:catAx>
      <c:valAx>
        <c:axId val="225370880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crossAx val="2199206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85000"/>
                <a:lumOff val="1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6:$D$14</c:f>
                <c:numCache>
                  <c:formatCode>General</c:formatCode>
                  <c:ptCount val="9"/>
                  <c:pt idx="0">
                    <c:v>9.7108709522209194E-2</c:v>
                  </c:pt>
                  <c:pt idx="1">
                    <c:v>0.39802839996884604</c:v>
                  </c:pt>
                  <c:pt idx="2">
                    <c:v>0.2372482614825</c:v>
                  </c:pt>
                  <c:pt idx="3">
                    <c:v>0.51206916972970218</c:v>
                  </c:pt>
                  <c:pt idx="4">
                    <c:v>0.23786872482614821</c:v>
                  </c:pt>
                  <c:pt idx="5">
                    <c:v>0.33378750684869085</c:v>
                  </c:pt>
                  <c:pt idx="6">
                    <c:v>7.033855518574364E-2</c:v>
                  </c:pt>
                  <c:pt idx="7">
                    <c:v>0.54489112652535499</c:v>
                  </c:pt>
                  <c:pt idx="8">
                    <c:v>0.167310182940455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B$6:$B$14</c:f>
              <c:strCache>
                <c:ptCount val="9"/>
                <c:pt idx="0">
                  <c:v>NEG</c:v>
                </c:pt>
                <c:pt idx="1">
                  <c:v>CCNB1</c:v>
                </c:pt>
                <c:pt idx="2">
                  <c:v>CCNB2</c:v>
                </c:pt>
                <c:pt idx="3">
                  <c:v>CDK1</c:v>
                </c:pt>
                <c:pt idx="4">
                  <c:v>TOP2A</c:v>
                </c:pt>
                <c:pt idx="5">
                  <c:v>USP15</c:v>
                </c:pt>
                <c:pt idx="6">
                  <c:v>MTCH1</c:v>
                </c:pt>
                <c:pt idx="7">
                  <c:v>SASH1</c:v>
                </c:pt>
                <c:pt idx="8">
                  <c:v>CDCA7L</c:v>
                </c:pt>
              </c:strCache>
            </c:strRef>
          </c:cat>
          <c:val>
            <c:numRef>
              <c:f>Sheet1!$C$6:$C$14</c:f>
              <c:numCache>
                <c:formatCode>General</c:formatCode>
                <c:ptCount val="9"/>
                <c:pt idx="0" formatCode="0.00">
                  <c:v>0.25</c:v>
                </c:pt>
                <c:pt idx="1">
                  <c:v>2.7277798299701801</c:v>
                </c:pt>
                <c:pt idx="2">
                  <c:v>3.3679551067500002</c:v>
                </c:pt>
                <c:pt idx="3" formatCode="0.00">
                  <c:v>2.6908366429434478</c:v>
                </c:pt>
                <c:pt idx="4" formatCode="0.00">
                  <c:v>4.8602492955106698</c:v>
                </c:pt>
                <c:pt idx="5" formatCode="0.00">
                  <c:v>2.2763249862619062</c:v>
                </c:pt>
                <c:pt idx="6" formatCode="0.00">
                  <c:v>3.6315001326034899</c:v>
                </c:pt>
                <c:pt idx="7" formatCode="0.00">
                  <c:v>4.0802198260923301</c:v>
                </c:pt>
                <c:pt idx="8" formatCode="0.00">
                  <c:v>3.57232914563221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69376"/>
        <c:axId val="248470912"/>
      </c:barChart>
      <c:catAx>
        <c:axId val="248469376"/>
        <c:scaling>
          <c:orientation val="minMax"/>
        </c:scaling>
        <c:delete val="0"/>
        <c:axPos val="b"/>
        <c:majorTickMark val="out"/>
        <c:minorTickMark val="none"/>
        <c:tickLblPos val="nextTo"/>
        <c:crossAx val="248470912"/>
        <c:crosses val="autoZero"/>
        <c:auto val="1"/>
        <c:lblAlgn val="ctr"/>
        <c:lblOffset val="100"/>
        <c:noMultiLvlLbl val="0"/>
      </c:catAx>
      <c:valAx>
        <c:axId val="248470912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crossAx val="24846937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1B45C1-70C3-46D4-A32A-FEF0581B8A5B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altLang="en-US" smtClean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197D4DD6-878A-4260-A1E7-ACE1E5C6D78E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177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1100" y="696913"/>
            <a:ext cx="4648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7D4DD6-878A-4260-A1E7-ACE1E5C6D78E}" type="slidenum">
              <a:rPr lang="en-US" altLang="en-US" smtClean="0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63318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3EAE41D-2269-4843-8591-71C50AAC54BE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DDE7CE2-2D80-40F5-ABAC-8DE69FF83D39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244653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39B5717-CCCB-4FCC-B6DE-385F92E03DA6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ADEAB87-A5B5-44D2-8973-06B1501D6E7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59841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70D7AE9-D5BB-4A40-92F2-1A42C23B9134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7AD86FC-0FFD-437C-A4A1-AD4734B614C6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2226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B9AD9D0F-96BD-45CF-98FC-244FD5D9E65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AAB62F0-F8E4-48F3-BEFD-4A18B9EB52E7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61588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DAA410-CDC7-4019-A096-24A8B774AE40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E0B0FEA-C3B0-4788-9007-28C3C6A23435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84402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EE92A3EB-8E61-4E4D-9D10-C62C6723DAF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99C0D-0EEF-4CC2-8A8B-BCAA9A67A1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27628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B5F3BEC-C0FB-49C7-8277-2CCE1C67C53A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811DA4F-9054-46D9-805D-342878FF837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254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4560479-DC70-46D5-AB77-FF9A6C1DDE94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D43EBC1-E17E-4201-A773-5D61902CA3ED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6143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9C22A94-A4ED-47F0-B336-47B01763B61B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57B61B1-0937-446C-A80A-89B6E80C866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16877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D44B365-877C-40C4-AA09-1F761367865E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B3C69BA-C42F-4B47-A7DC-D122A2062860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48573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1D234A69-B555-4775-91C3-908FFDC622B8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B703BB-9289-49B9-BB2D-7ED69C5982CB}" type="slidenum">
              <a:rPr lang="en-US" altLang="en-US"/>
              <a:pPr/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334694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5123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2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fld id="{ED3AAABA-8377-4DC6-85F9-8CCA4D29B76F}" type="datetimeFigureOut">
              <a:rPr lang="en-US" altLang="en-US"/>
              <a:pPr/>
              <a:t>5/8/2015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fld id="{7098F2EA-2152-4D8B-AE61-139F6DDF9A3D}" type="slidenum">
              <a:rPr lang="en-US" altLang="en-US"/>
              <a:pPr/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Chart 6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8408090"/>
              </p:ext>
            </p:extLst>
          </p:nvPr>
        </p:nvGraphicFramePr>
        <p:xfrm>
          <a:off x="4918826" y="1905391"/>
          <a:ext cx="3508720" cy="25275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2" name="Chart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9595121"/>
              </p:ext>
            </p:extLst>
          </p:nvPr>
        </p:nvGraphicFramePr>
        <p:xfrm>
          <a:off x="1059874" y="1911380"/>
          <a:ext cx="3511726" cy="24976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717209" y="1793034"/>
            <a:ext cx="311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571600" y="1793034"/>
            <a:ext cx="3113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6329333" y="6131958"/>
            <a:ext cx="26231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5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782874" y="1885367"/>
            <a:ext cx="7573926" cy="2772321"/>
            <a:chOff x="392687" y="626278"/>
            <a:chExt cx="7573926" cy="2772321"/>
          </a:xfrm>
        </p:grpSpPr>
        <p:grpSp>
          <p:nvGrpSpPr>
            <p:cNvPr id="28" name="Group 27"/>
            <p:cNvGrpSpPr/>
            <p:nvPr/>
          </p:nvGrpSpPr>
          <p:grpSpPr>
            <a:xfrm>
              <a:off x="1402054" y="3083068"/>
              <a:ext cx="2687883" cy="282098"/>
              <a:chOff x="1759958" y="5956395"/>
              <a:chExt cx="2687882" cy="282098"/>
            </a:xfrm>
          </p:grpSpPr>
          <p:cxnSp>
            <p:nvCxnSpPr>
              <p:cNvPr id="29" name="Straight Connector 28"/>
              <p:cNvCxnSpPr/>
              <p:nvPr/>
            </p:nvCxnSpPr>
            <p:spPr>
              <a:xfrm>
                <a:off x="1759958" y="5989827"/>
                <a:ext cx="118837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3153124" y="5989827"/>
                <a:ext cx="56127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11"/>
              <p:cNvSpPr txBox="1">
                <a:spLocks noChangeArrowheads="1"/>
              </p:cNvSpPr>
              <p:nvPr/>
            </p:nvSpPr>
            <p:spPr bwMode="auto">
              <a:xfrm>
                <a:off x="1967255" y="5956395"/>
                <a:ext cx="66164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200" dirty="0" smtClean="0"/>
                  <a:t>Motif 1</a:t>
                </a:r>
                <a:endParaRPr lang="en-US" altLang="en-US" sz="1200" dirty="0"/>
              </a:p>
            </p:txBody>
          </p:sp>
          <p:cxnSp>
            <p:nvCxnSpPr>
              <p:cNvPr id="33" name="Straight Connector 32"/>
              <p:cNvCxnSpPr/>
              <p:nvPr/>
            </p:nvCxnSpPr>
            <p:spPr>
              <a:xfrm>
                <a:off x="3817355" y="5997954"/>
                <a:ext cx="56127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" name="TextBox 11"/>
              <p:cNvSpPr txBox="1">
                <a:spLocks noChangeArrowheads="1"/>
              </p:cNvSpPr>
              <p:nvPr/>
            </p:nvSpPr>
            <p:spPr bwMode="auto">
              <a:xfrm>
                <a:off x="3117951" y="5961494"/>
                <a:ext cx="66164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200" dirty="0" smtClean="0"/>
                  <a:t>Motif 2</a:t>
                </a:r>
                <a:endParaRPr lang="en-US" altLang="en-US" sz="1200" dirty="0"/>
              </a:p>
            </p:txBody>
          </p:sp>
          <p:sp>
            <p:nvSpPr>
              <p:cNvPr id="35" name="TextBox 11"/>
              <p:cNvSpPr txBox="1">
                <a:spLocks noChangeArrowheads="1"/>
              </p:cNvSpPr>
              <p:nvPr/>
            </p:nvSpPr>
            <p:spPr bwMode="auto">
              <a:xfrm>
                <a:off x="3786193" y="5961494"/>
                <a:ext cx="66164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200" dirty="0" smtClean="0"/>
                  <a:t>Motif 3</a:t>
                </a:r>
                <a:endParaRPr lang="en-US" altLang="en-US" sz="1200" dirty="0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5278730" y="3116501"/>
              <a:ext cx="2687883" cy="282098"/>
              <a:chOff x="1759958" y="5956395"/>
              <a:chExt cx="2687882" cy="282098"/>
            </a:xfrm>
          </p:grpSpPr>
          <p:cxnSp>
            <p:nvCxnSpPr>
              <p:cNvPr id="37" name="Straight Connector 36"/>
              <p:cNvCxnSpPr/>
              <p:nvPr/>
            </p:nvCxnSpPr>
            <p:spPr>
              <a:xfrm>
                <a:off x="1759958" y="5989827"/>
                <a:ext cx="118837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3153124" y="5989827"/>
                <a:ext cx="56127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11"/>
              <p:cNvSpPr txBox="1">
                <a:spLocks noChangeArrowheads="1"/>
              </p:cNvSpPr>
              <p:nvPr/>
            </p:nvSpPr>
            <p:spPr bwMode="auto">
              <a:xfrm>
                <a:off x="1967255" y="5956395"/>
                <a:ext cx="66164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200" dirty="0" smtClean="0"/>
                  <a:t>Motif 1</a:t>
                </a:r>
                <a:endParaRPr lang="en-US" altLang="en-US" sz="1200" dirty="0"/>
              </a:p>
            </p:txBody>
          </p:sp>
          <p:cxnSp>
            <p:nvCxnSpPr>
              <p:cNvPr id="40" name="Straight Connector 39"/>
              <p:cNvCxnSpPr/>
              <p:nvPr/>
            </p:nvCxnSpPr>
            <p:spPr>
              <a:xfrm>
                <a:off x="3817355" y="5997954"/>
                <a:ext cx="56127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11"/>
              <p:cNvSpPr txBox="1">
                <a:spLocks noChangeArrowheads="1"/>
              </p:cNvSpPr>
              <p:nvPr/>
            </p:nvSpPr>
            <p:spPr bwMode="auto">
              <a:xfrm>
                <a:off x="3117951" y="5961494"/>
                <a:ext cx="66164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200" dirty="0" smtClean="0"/>
                  <a:t>Motif 2</a:t>
                </a:r>
                <a:endParaRPr lang="en-US" altLang="en-US" sz="1200" dirty="0"/>
              </a:p>
            </p:txBody>
          </p:sp>
          <p:sp>
            <p:nvSpPr>
              <p:cNvPr id="42" name="TextBox 11"/>
              <p:cNvSpPr txBox="1">
                <a:spLocks noChangeArrowheads="1"/>
              </p:cNvSpPr>
              <p:nvPr/>
            </p:nvSpPr>
            <p:spPr bwMode="auto">
              <a:xfrm>
                <a:off x="3786193" y="5961494"/>
                <a:ext cx="66164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defTabSz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altLang="en-US" sz="1200" dirty="0" smtClean="0"/>
                  <a:t>Motif 3</a:t>
                </a:r>
                <a:endParaRPr lang="en-US" altLang="en-US" sz="1200" dirty="0"/>
              </a:p>
            </p:txBody>
          </p:sp>
        </p:grpSp>
        <p:sp>
          <p:nvSpPr>
            <p:cNvPr id="43" name="Rectangle 42"/>
            <p:cNvSpPr/>
            <p:nvPr/>
          </p:nvSpPr>
          <p:spPr>
            <a:xfrm>
              <a:off x="1001889" y="626278"/>
              <a:ext cx="169809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 smtClean="0"/>
                <a:t>ChIP-qPCR</a:t>
              </a:r>
              <a:r>
                <a:rPr lang="en-US" sz="1200" dirty="0" smtClean="0"/>
                <a:t> for anti-SOX9</a:t>
              </a:r>
              <a:endParaRPr lang="en-US" sz="1200" dirty="0"/>
            </a:p>
          </p:txBody>
        </p:sp>
        <p:sp>
          <p:nvSpPr>
            <p:cNvPr id="44" name="Rectangle 43"/>
            <p:cNvSpPr/>
            <p:nvPr/>
          </p:nvSpPr>
          <p:spPr>
            <a:xfrm>
              <a:off x="4973522" y="652291"/>
              <a:ext cx="174118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err="1" smtClean="0"/>
                <a:t>ChIP-qPCR</a:t>
              </a:r>
              <a:r>
                <a:rPr lang="en-US" sz="1200" dirty="0" smtClean="0"/>
                <a:t> for anti-NF-YA</a:t>
              </a:r>
              <a:endParaRPr lang="en-US" sz="1200" dirty="0"/>
            </a:p>
          </p:txBody>
        </p:sp>
        <p:sp>
          <p:nvSpPr>
            <p:cNvPr id="47" name="TextBox 1"/>
            <p:cNvSpPr txBox="1">
              <a:spLocks noChangeArrowheads="1"/>
            </p:cNvSpPr>
            <p:nvPr/>
          </p:nvSpPr>
          <p:spPr bwMode="auto">
            <a:xfrm rot="16200000">
              <a:off x="2714" y="1436313"/>
              <a:ext cx="105694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% of input</a:t>
              </a:r>
              <a:endParaRPr lang="en-US" altLang="en-US" sz="1200" dirty="0"/>
            </a:p>
          </p:txBody>
        </p:sp>
        <p:sp>
          <p:nvSpPr>
            <p:cNvPr id="48" name="TextBox 1"/>
            <p:cNvSpPr txBox="1">
              <a:spLocks noChangeArrowheads="1"/>
            </p:cNvSpPr>
            <p:nvPr/>
          </p:nvSpPr>
          <p:spPr bwMode="auto">
            <a:xfrm rot="16200000">
              <a:off x="3943337" y="1421316"/>
              <a:ext cx="102695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eaLnBrk="1" hangingPunct="1"/>
              <a:r>
                <a:rPr lang="en-US" altLang="en-US" sz="1200" dirty="0" smtClean="0"/>
                <a:t>% of input</a:t>
              </a:r>
              <a:endParaRPr lang="en-US" alt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578144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050</TotalTime>
  <Words>30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enpathwa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ME runs</dc:title>
  <dc:creator>Paul Labhart</dc:creator>
  <cp:lastModifiedBy>Shi, Zhongcheng</cp:lastModifiedBy>
  <cp:revision>1581</cp:revision>
  <cp:lastPrinted>2014-02-08T00:35:07Z</cp:lastPrinted>
  <dcterms:created xsi:type="dcterms:W3CDTF">2013-01-30T00:52:15Z</dcterms:created>
  <dcterms:modified xsi:type="dcterms:W3CDTF">2015-05-08T18:55:18Z</dcterms:modified>
</cp:coreProperties>
</file>